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wmf" ContentType="image/x-wmf"/>
  <Override PartName="/ppt/media/image9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0085A-9310-4522-B52C-1973B104AE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3F940-3AAC-4E46-AE81-CBEA689BAB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2529F-D088-4B5D-B334-888B9D7C83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51F74-C84F-4047-83EB-C036199BD9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A6D9B8-DB12-4A23-B76B-93FDBBC9F2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878C0-9E6A-4985-89EC-56EC970CAD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324606-2309-4A48-BBA1-E7D330776F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4A2DC-2D38-405E-B050-5E57CECED5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71280-1E8E-4798-AAE9-876E6C0F36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4AD73-7487-4DB7-AF49-6C768B4207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487EB-6F5B-4610-AAEA-F3226369B3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51262-38DC-4E20-88AB-6434F5FF34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52554F-9AF4-4357-A672-7CEE428D7106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群組 14"/>
          <p:cNvGrpSpPr/>
          <p:nvPr/>
        </p:nvGrpSpPr>
        <p:grpSpPr>
          <a:xfrm>
            <a:off x="527040" y="754200"/>
            <a:ext cx="11023560" cy="5341320"/>
            <a:chOff x="527040" y="754200"/>
            <a:chExt cx="11023560" cy="5341320"/>
          </a:xfrm>
        </p:grpSpPr>
        <p:sp>
          <p:nvSpPr>
            <p:cNvPr id="42" name="矩形 3"/>
            <p:cNvSpPr/>
            <p:nvPr/>
          </p:nvSpPr>
          <p:spPr>
            <a:xfrm>
              <a:off x="930600" y="4722840"/>
              <a:ext cx="10570320" cy="1372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01"/>
                </a:spcBef>
                <a:spcAft>
                  <a:spcPts val="11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Supplementary Figure 1.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The combination of MK-2206, BEZ-235, cisplatin and doxorubicin with #43 in MCF-7 breast cancer cells, and  SKOV3 and ES2 ovarian cancer cells. Cells were treated with indicated drugs for 72 h and then subjected to the MTT assay to measure the cell viability. Data are presented as mean ± SEM ( n = 3).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MK: MK-2206, BEZ: BEZ-235, CDDP: cisplatin, Dox: doxorubicin. Cisplatin consistently showed a better combinatorial effect with #43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in all cell lines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(highlighted with red rectangles)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群組 13"/>
            <p:cNvGrpSpPr/>
            <p:nvPr/>
          </p:nvGrpSpPr>
          <p:grpSpPr>
            <a:xfrm>
              <a:off x="527040" y="754200"/>
              <a:ext cx="11023560" cy="3790800"/>
              <a:chOff x="527040" y="754200"/>
              <a:chExt cx="11023560" cy="3790800"/>
            </a:xfrm>
          </p:grpSpPr>
          <p:grpSp>
            <p:nvGrpSpPr>
              <p:cNvPr id="44" name="群組 4"/>
              <p:cNvGrpSpPr/>
              <p:nvPr/>
            </p:nvGrpSpPr>
            <p:grpSpPr>
              <a:xfrm>
                <a:off x="527040" y="754200"/>
                <a:ext cx="3483360" cy="3753000"/>
                <a:chOff x="527040" y="754200"/>
                <a:chExt cx="3483360" cy="3753000"/>
              </a:xfrm>
            </p:grpSpPr>
            <p:graphicFrame>
              <p:nvGraphicFramePr>
                <p:cNvPr id="45" name="Object 12"/>
                <p:cNvGraphicFramePr/>
                <p:nvPr/>
              </p:nvGraphicFramePr>
              <p:xfrm>
                <a:off x="1133640" y="3956400"/>
                <a:ext cx="2111040" cy="550800"/>
              </p:xfrm>
              <a:graphic>
                <a:graphicData uri="http://schemas.openxmlformats.org/presentationml/2006/ole">
                  <p:oleObj r:id="rId1" spid="">
                    <p:embed/>
                    <p:pic>
                      <p:nvPicPr>
                        <p:cNvPr id="46" name="Object 12" descr=""/>
                        <p:cNvPicPr/>
                        <p:nvPr/>
                      </p:nvPicPr>
                      <p:blipFill>
                        <a:blip r:embed="rId2"/>
                        <a:stretch/>
                      </p:blipFill>
                      <p:spPr>
                        <a:xfrm>
                          <a:off x="1133640" y="3956400"/>
                          <a:ext cx="2111040" cy="55080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pSp>
              <p:nvGrpSpPr>
                <p:cNvPr id="47" name="群組 3"/>
                <p:cNvGrpSpPr/>
                <p:nvPr/>
              </p:nvGrpSpPr>
              <p:grpSpPr>
                <a:xfrm>
                  <a:off x="527040" y="754200"/>
                  <a:ext cx="3483360" cy="3198240"/>
                  <a:chOff x="527040" y="754200"/>
                  <a:chExt cx="3483360" cy="3198240"/>
                </a:xfrm>
              </p:grpSpPr>
              <p:pic>
                <p:nvPicPr>
                  <p:cNvPr id="48" name="圖片 1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527040" y="754200"/>
                    <a:ext cx="3483360" cy="3198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9" name="Rectangle 19"/>
                  <p:cNvSpPr/>
                  <p:nvPr/>
                </p:nvSpPr>
                <p:spPr>
                  <a:xfrm>
                    <a:off x="3022920" y="2215080"/>
                    <a:ext cx="464760" cy="960480"/>
                  </a:xfrm>
                  <a:prstGeom prst="rect">
                    <a:avLst/>
                  </a:prstGeom>
                  <a:noFill/>
                  <a:ln w="9360">
                    <a:solidFill>
                      <a:srgbClr val="ff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0" name="群組 7"/>
              <p:cNvGrpSpPr/>
              <p:nvPr/>
            </p:nvGrpSpPr>
            <p:grpSpPr>
              <a:xfrm>
                <a:off x="4312440" y="765000"/>
                <a:ext cx="3453120" cy="3780000"/>
                <a:chOff x="4312440" y="765000"/>
                <a:chExt cx="3453120" cy="3780000"/>
              </a:xfrm>
            </p:grpSpPr>
            <p:graphicFrame>
              <p:nvGraphicFramePr>
                <p:cNvPr id="51" name="Object 14"/>
                <p:cNvGraphicFramePr/>
                <p:nvPr/>
              </p:nvGraphicFramePr>
              <p:xfrm>
                <a:off x="4879800" y="3956040"/>
                <a:ext cx="2146320" cy="588960"/>
              </p:xfrm>
              <a:graphic>
                <a:graphicData uri="http://schemas.openxmlformats.org/presentationml/2006/ole">
                  <p:oleObj r:id="rId4" spid="">
                    <p:embed/>
                    <p:pic>
                      <p:nvPicPr>
                        <p:cNvPr id="52" name="Object 14" descr=""/>
                        <p:cNvPicPr/>
                        <p:nvPr/>
                      </p:nvPicPr>
                      <p:blipFill>
                        <a:blip r:embed="rId5"/>
                        <a:stretch/>
                      </p:blipFill>
                      <p:spPr>
                        <a:xfrm>
                          <a:off x="4879800" y="3956040"/>
                          <a:ext cx="2146320" cy="5889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pSp>
              <p:nvGrpSpPr>
                <p:cNvPr id="53" name="群組 6"/>
                <p:cNvGrpSpPr/>
                <p:nvPr/>
              </p:nvGrpSpPr>
              <p:grpSpPr>
                <a:xfrm>
                  <a:off x="4312440" y="765000"/>
                  <a:ext cx="3453120" cy="3210120"/>
                  <a:chOff x="4312440" y="765000"/>
                  <a:chExt cx="3453120" cy="3210120"/>
                </a:xfrm>
              </p:grpSpPr>
              <p:pic>
                <p:nvPicPr>
                  <p:cNvPr id="54" name="圖片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312440" y="765000"/>
                    <a:ext cx="3453120" cy="321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55" name="Rectangle 20"/>
                  <p:cNvSpPr/>
                  <p:nvPr/>
                </p:nvSpPr>
                <p:spPr>
                  <a:xfrm>
                    <a:off x="6778440" y="2234520"/>
                    <a:ext cx="465120" cy="960480"/>
                  </a:xfrm>
                  <a:prstGeom prst="rect">
                    <a:avLst/>
                  </a:prstGeom>
                  <a:noFill/>
                  <a:ln w="9360">
                    <a:solidFill>
                      <a:srgbClr val="ff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6" name="群組 12"/>
              <p:cNvGrpSpPr/>
              <p:nvPr/>
            </p:nvGrpSpPr>
            <p:grpSpPr>
              <a:xfrm>
                <a:off x="8055000" y="758520"/>
                <a:ext cx="3495600" cy="3762720"/>
                <a:chOff x="8055000" y="758520"/>
                <a:chExt cx="3495600" cy="3762720"/>
              </a:xfrm>
            </p:grpSpPr>
            <p:graphicFrame>
              <p:nvGraphicFramePr>
                <p:cNvPr id="57" name="Object 13"/>
                <p:cNvGraphicFramePr/>
                <p:nvPr/>
              </p:nvGraphicFramePr>
              <p:xfrm>
                <a:off x="8694360" y="3944880"/>
                <a:ext cx="2050920" cy="576360"/>
              </p:xfrm>
              <a:graphic>
                <a:graphicData uri="http://schemas.openxmlformats.org/presentationml/2006/ole">
                  <p:oleObj r:id="rId7" spid="">
                    <p:embed/>
                    <p:pic>
                      <p:nvPicPr>
                        <p:cNvPr id="58" name="Object 13" descr=""/>
                        <p:cNvPicPr/>
                        <p:nvPr/>
                      </p:nvPicPr>
                      <p:blipFill>
                        <a:blip r:embed="rId8"/>
                        <a:stretch/>
                      </p:blipFill>
                      <p:spPr>
                        <a:xfrm>
                          <a:off x="8694360" y="3944880"/>
                          <a:ext cx="2050920" cy="576360"/>
                        </a:xfrm>
                        <a:prstGeom prst="rect">
                          <a:avLst/>
                        </a:prstGeom>
                        <a:ln w="0">
                          <a:noFill/>
                        </a:ln>
                      </p:spPr>
                    </p:pic>
                  </p:oleObj>
                </a:graphicData>
              </a:graphic>
            </p:graphicFrame>
            <p:grpSp>
              <p:nvGrpSpPr>
                <p:cNvPr id="59" name="群組 11"/>
                <p:cNvGrpSpPr/>
                <p:nvPr/>
              </p:nvGrpSpPr>
              <p:grpSpPr>
                <a:xfrm>
                  <a:off x="8055000" y="758520"/>
                  <a:ext cx="3495600" cy="3173760"/>
                  <a:chOff x="8055000" y="758520"/>
                  <a:chExt cx="3495600" cy="3173760"/>
                </a:xfrm>
              </p:grpSpPr>
              <p:pic>
                <p:nvPicPr>
                  <p:cNvPr id="60" name="圖片 9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8055000" y="758520"/>
                    <a:ext cx="3495600" cy="3173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1" name="Rectangle 21"/>
                  <p:cNvSpPr/>
                  <p:nvPr/>
                </p:nvSpPr>
                <p:spPr>
                  <a:xfrm>
                    <a:off x="10550160" y="2136600"/>
                    <a:ext cx="465120" cy="1056240"/>
                  </a:xfrm>
                  <a:prstGeom prst="rect">
                    <a:avLst/>
                  </a:prstGeom>
                  <a:noFill/>
                  <a:ln w="9360">
                    <a:solidFill>
                      <a:srgbClr val="ff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群組 2"/>
          <p:cNvGrpSpPr/>
          <p:nvPr/>
        </p:nvGrpSpPr>
        <p:grpSpPr>
          <a:xfrm>
            <a:off x="930240" y="830160"/>
            <a:ext cx="10571040" cy="4991040"/>
            <a:chOff x="930240" y="830160"/>
            <a:chExt cx="10571040" cy="4991040"/>
          </a:xfrm>
        </p:grpSpPr>
        <p:sp>
          <p:nvSpPr>
            <p:cNvPr id="63" name="矩形 3"/>
            <p:cNvSpPr/>
            <p:nvPr/>
          </p:nvSpPr>
          <p:spPr>
            <a:xfrm>
              <a:off x="930240" y="4722840"/>
              <a:ext cx="10571040" cy="10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01"/>
                </a:spcBef>
                <a:spcAft>
                  <a:spcPts val="11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Supplementary Figure 2.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The combination of cisplatin with #43 in MDA-MB-231 breast cancer cells. Cells were treated with indicated drugs for 72 h and then subjected to the MTT assay to measure the cell viability. Data are presented as mean ± SEM ( n = 2-3).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CDDP: cisplatin. #43 enhanced the growth inhibitory effect of both 5 and 10 μM cisplatin. However, the combinatorial effect of 5 μM cisplatin and 10 μM #43 was slightly better (highlighted with red a rectangle)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" name="群組 1"/>
            <p:cNvGrpSpPr/>
            <p:nvPr/>
          </p:nvGrpSpPr>
          <p:grpSpPr>
            <a:xfrm>
              <a:off x="3240000" y="830160"/>
              <a:ext cx="5648400" cy="3548160"/>
              <a:chOff x="3240000" y="830160"/>
              <a:chExt cx="5648400" cy="3548160"/>
            </a:xfrm>
          </p:grpSpPr>
          <p:pic>
            <p:nvPicPr>
              <p:cNvPr id="65" name="Picture 7" descr="231 chemo combined #43_012822"/>
              <p:cNvPicPr/>
              <p:nvPr/>
            </p:nvPicPr>
            <p:blipFill>
              <a:blip r:embed="rId1"/>
              <a:stretch/>
            </p:blipFill>
            <p:spPr>
              <a:xfrm>
                <a:off x="3240000" y="830160"/>
                <a:ext cx="5648400" cy="35481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Rectangle 9"/>
              <p:cNvSpPr/>
              <p:nvPr/>
            </p:nvSpPr>
            <p:spPr>
              <a:xfrm>
                <a:off x="3985560" y="2062080"/>
                <a:ext cx="748440" cy="1417680"/>
              </a:xfrm>
              <a:prstGeom prst="rect">
                <a:avLst/>
              </a:prstGeom>
              <a:noFill/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群組 1"/>
          <p:cNvGrpSpPr/>
          <p:nvPr/>
        </p:nvGrpSpPr>
        <p:grpSpPr>
          <a:xfrm>
            <a:off x="930240" y="1228680"/>
            <a:ext cx="10571040" cy="4349160"/>
            <a:chOff x="930240" y="1228680"/>
            <a:chExt cx="10571040" cy="4349160"/>
          </a:xfrm>
        </p:grpSpPr>
        <p:sp>
          <p:nvSpPr>
            <p:cNvPr id="68" name="矩形 3"/>
            <p:cNvSpPr/>
            <p:nvPr/>
          </p:nvSpPr>
          <p:spPr>
            <a:xfrm>
              <a:off x="930240" y="4722840"/>
              <a:ext cx="10571040" cy="85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01"/>
                </a:spcBef>
                <a:spcAft>
                  <a:spcPts val="11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Supplementary Figure 3.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The combination of cisplatin and #43 is synergistic against MDA-MB-231 breast cancer cells determined by the SRB assay. Cells were treated with indicated drugs for 72 h and then subjected to the SRB assay to measure the cell viability. Data are presented as mean ± SEM.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CDDP: cisplatin.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69" name="物件 1"/>
            <p:cNvGraphicFramePr/>
            <p:nvPr/>
          </p:nvGraphicFramePr>
          <p:xfrm>
            <a:off x="3141360" y="1228680"/>
            <a:ext cx="5324400" cy="29275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70" name="物件 1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141360" y="1228680"/>
                      <a:ext cx="5324400" cy="2927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矩形 3"/>
          <p:cNvSpPr/>
          <p:nvPr/>
        </p:nvSpPr>
        <p:spPr>
          <a:xfrm>
            <a:off x="930240" y="4722840"/>
            <a:ext cx="1057104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ure 4.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The combination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GLUT1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knockdown and cisplatin is synergistic in MCF-7 breast cancer cells.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(A)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Dose-effect curve. Fa: the fraction that is affected or inhibited; CDDP: 10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 cisplatin ; siG1: siGLUT1; combo: combination of siG1 and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DDP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(B)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Normalized isobologram. Data set shown in Fig. 2B was subjected to analysis using CompuSyn software to obtain the graph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combination of siGLUT1 and 10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 cisplatin had a greater Fa than siGLUT1 or 10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 cisplatin alone (A), and displayed a synergistic effect (below the additive effect line in B) with a CI value of 0.648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12"/>
          <p:cNvSpPr/>
          <p:nvPr/>
        </p:nvSpPr>
        <p:spPr>
          <a:xfrm>
            <a:off x="8793000" y="1890720"/>
            <a:ext cx="389160" cy="314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圖片 1" descr=""/>
          <p:cNvPicPr/>
          <p:nvPr/>
        </p:nvPicPr>
        <p:blipFill>
          <a:blip r:embed="rId1"/>
          <a:stretch/>
        </p:blipFill>
        <p:spPr>
          <a:xfrm>
            <a:off x="1255680" y="830160"/>
            <a:ext cx="9506160" cy="394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群組 1"/>
          <p:cNvGrpSpPr/>
          <p:nvPr/>
        </p:nvGrpSpPr>
        <p:grpSpPr>
          <a:xfrm>
            <a:off x="930240" y="1442880"/>
            <a:ext cx="10571040" cy="4590720"/>
            <a:chOff x="930240" y="1442880"/>
            <a:chExt cx="10571040" cy="4590720"/>
          </a:xfrm>
        </p:grpSpPr>
        <p:grpSp>
          <p:nvGrpSpPr>
            <p:cNvPr id="75" name="Group 8"/>
            <p:cNvGrpSpPr/>
            <p:nvPr/>
          </p:nvGrpSpPr>
          <p:grpSpPr>
            <a:xfrm>
              <a:off x="1618920" y="1442880"/>
              <a:ext cx="7975440" cy="3113280"/>
              <a:chOff x="1618920" y="1442880"/>
              <a:chExt cx="7975440" cy="3113280"/>
            </a:xfrm>
          </p:grpSpPr>
          <p:pic>
            <p:nvPicPr>
              <p:cNvPr id="76" name="Picture 4" descr="231 N=3 MK-2206+#43_020222"/>
              <p:cNvPicPr/>
              <p:nvPr/>
            </p:nvPicPr>
            <p:blipFill>
              <a:blip r:embed="rId1"/>
              <a:stretch/>
            </p:blipFill>
            <p:spPr>
              <a:xfrm>
                <a:off x="1618920" y="1450800"/>
                <a:ext cx="3645000" cy="3105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Picture 5" descr="231 N=3 U0126+#43"/>
              <p:cNvPicPr/>
              <p:nvPr/>
            </p:nvPicPr>
            <p:blipFill>
              <a:blip r:embed="rId2"/>
              <a:stretch/>
            </p:blipFill>
            <p:spPr>
              <a:xfrm>
                <a:off x="5976720" y="1442880"/>
                <a:ext cx="3617640" cy="30751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8" name="矩形 3"/>
            <p:cNvSpPr/>
            <p:nvPr/>
          </p:nvSpPr>
          <p:spPr>
            <a:xfrm>
              <a:off x="930240" y="4722840"/>
              <a:ext cx="1057104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01"/>
                </a:spcBef>
                <a:spcAft>
                  <a:spcPts val="1199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Supplementary Figure 5.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Both Akt inhibitor MK-2206 and MEK inhibitor U0126 enhance the growth inhibitory effect of #43 in MDA-MB-231 breast cancer cells. Cells were treated with 20 μM #43 and indicated drugs either alone or in combination for 72 h and then subjected to the MTT assay to measure the cell viability. Data are presented as mean ± SEM ( n = 3). MK1 or MK2: 1 or 2 μM MK-2206, U5 or U10: 5 or 10 μM U0126. **, 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&lt; 0.01; ***, 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Times New Roman"/>
                </a:rPr>
                <a:t>P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 &lt; 0.001 by one-way ANOVA followed by Bonferroni</a:t>
              </a:r>
              <a:r>
                <a:rPr b="0" i="1" lang="en-US" sz="1600" spc="-1" strike="noStrike">
                  <a:solidFill>
                    <a:srgbClr val="000000"/>
                  </a:solidFill>
                  <a:latin typeface="Times New Roman"/>
                </a:rPr>
                <a:t> t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-test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矩形 3"/>
          <p:cNvSpPr/>
          <p:nvPr/>
        </p:nvSpPr>
        <p:spPr>
          <a:xfrm>
            <a:off x="930240" y="4722840"/>
            <a:ext cx="10571040" cy="855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ure 6.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The combination of cisplatin and #43 shows a moderate synergistic effect against T47D breast cancer cells. Cells were treated with indicated drugs for 72 h and then subjected to the MTT assay to measure the cell viability. Data are presented as mean ± SEM (n = 4)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CDDP: cisplatin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圖片 1" descr=""/>
          <p:cNvPicPr/>
          <p:nvPr/>
        </p:nvPicPr>
        <p:blipFill>
          <a:blip r:embed="rId1"/>
          <a:stretch/>
        </p:blipFill>
        <p:spPr>
          <a:xfrm>
            <a:off x="3224160" y="1332000"/>
            <a:ext cx="5292720" cy="2898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矩形 3"/>
          <p:cNvSpPr/>
          <p:nvPr/>
        </p:nvSpPr>
        <p:spPr>
          <a:xfrm>
            <a:off x="930240" y="4722840"/>
            <a:ext cx="1057104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01"/>
              </a:spcBef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ry Figure 7.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The combination of #43, WZB117 and BAY-876 with cisplatin in MCF-7 breast cancer cells. Cells were treated with indicated drugs for 72 h and then subjected to the MTT assay to measure the cell viability. Data are presented as mean ± SEM ( n = 3)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CDDP10 or 20: 10 or 20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 cisplatin, #43 10 or 20: 10 or 20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 #43, BAY1 or 2: 1 or 2 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M BAY-876. The combination of #43 with cisplatin showed a  good synergistic effect, while BAY-876 only had an additive effect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圖片 1" descr=""/>
          <p:cNvPicPr/>
          <p:nvPr/>
        </p:nvPicPr>
        <p:blipFill>
          <a:blip r:embed="rId1"/>
          <a:stretch/>
        </p:blipFill>
        <p:spPr>
          <a:xfrm>
            <a:off x="3659040" y="996840"/>
            <a:ext cx="3730680" cy="3538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1-11T13:13:02Z</dcterms:created>
  <dc:creator>Microsoft Office 使用者</dc:creator>
  <dc:description/>
  <dc:language>en-US</dc:language>
  <cp:lastModifiedBy>PC</cp:lastModifiedBy>
  <dcterms:modified xsi:type="dcterms:W3CDTF">2022-04-28T11:10:20Z</dcterms:modified>
  <cp:revision>41</cp:revision>
  <dc:subject/>
  <dc:title>PowerPoint 簡報</dc:title>
</cp:coreProperties>
</file>